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1F3CF6B-BC69-4343-9209-F0998CBB8C20}" v="1" dt="2023-09-26T00:22:23.37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5" autoAdjust="0"/>
    <p:restoredTop sz="82884" autoAdjust="0"/>
  </p:normalViewPr>
  <p:slideViewPr>
    <p:cSldViewPr snapToGrid="0">
      <p:cViewPr varScale="1">
        <p:scale>
          <a:sx n="52" d="100"/>
          <a:sy n="52" d="100"/>
        </p:scale>
        <p:origin x="1600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前川　正充" userId="ec498de6-dd87-4767-be4a-a3286ad2b65a" providerId="ADAL" clId="{4904D7FA-AF3D-4ED2-B925-8F53F188FB55}"/>
    <pc:docChg chg="custSel modSld">
      <pc:chgData name="前川　正充" userId="ec498de6-dd87-4767-be4a-a3286ad2b65a" providerId="ADAL" clId="{4904D7FA-AF3D-4ED2-B925-8F53F188FB55}" dt="2022-12-28T06:31:29.787" v="73" actId="20577"/>
      <pc:docMkLst>
        <pc:docMk/>
      </pc:docMkLst>
      <pc:sldChg chg="modNotesTx">
        <pc:chgData name="前川　正充" userId="ec498de6-dd87-4767-be4a-a3286ad2b65a" providerId="ADAL" clId="{4904D7FA-AF3D-4ED2-B925-8F53F188FB55}" dt="2022-12-28T06:31:29.787" v="73" actId="20577"/>
        <pc:sldMkLst>
          <pc:docMk/>
          <pc:sldMk cId="3509598072" sldId="266"/>
        </pc:sldMkLst>
      </pc:sldChg>
    </pc:docChg>
  </pc:docChgLst>
  <pc:docChgLst>
    <pc:chgData name="三好　慶太郎" userId="885fdf61-c477-4ebd-a6d8-2867af3f3102" providerId="ADAL" clId="{61F3CF6B-BC69-4343-9209-F0998CBB8C20}"/>
    <pc:docChg chg="undo custSel modSld">
      <pc:chgData name="三好　慶太郎" userId="885fdf61-c477-4ebd-a6d8-2867af3f3102" providerId="ADAL" clId="{61F3CF6B-BC69-4343-9209-F0998CBB8C20}" dt="2023-09-26T01:14:58.380" v="17" actId="113"/>
      <pc:docMkLst>
        <pc:docMk/>
      </pc:docMkLst>
      <pc:sldChg chg="modSp mod modNotesTx">
        <pc:chgData name="三好　慶太郎" userId="885fdf61-c477-4ebd-a6d8-2867af3f3102" providerId="ADAL" clId="{61F3CF6B-BC69-4343-9209-F0998CBB8C20}" dt="2023-09-26T01:14:58.380" v="17" actId="113"/>
        <pc:sldMkLst>
          <pc:docMk/>
          <pc:sldMk cId="3509598072" sldId="266"/>
        </pc:sldMkLst>
        <pc:spChg chg="mod">
          <ac:chgData name="三好　慶太郎" userId="885fdf61-c477-4ebd-a6d8-2867af3f3102" providerId="ADAL" clId="{61F3CF6B-BC69-4343-9209-F0998CBB8C20}" dt="2023-09-26T00:21:47.388" v="10" actId="20577"/>
          <ac:spMkLst>
            <pc:docMk/>
            <pc:sldMk cId="3509598072" sldId="266"/>
            <ac:spMk id="2" creationId="{99DF83ED-CF62-EB2C-95DE-5CC12BA29E26}"/>
          </ac:spMkLst>
        </pc:spChg>
        <pc:spChg chg="mod">
          <ac:chgData name="三好　慶太郎" userId="885fdf61-c477-4ebd-a6d8-2867af3f3102" providerId="ADAL" clId="{61F3CF6B-BC69-4343-9209-F0998CBB8C20}" dt="2023-09-20T05:21:20.555" v="4" actId="20577"/>
          <ac:spMkLst>
            <pc:docMk/>
            <pc:sldMk cId="3509598072" sldId="266"/>
            <ac:spMk id="35" creationId="{00000000-0000-0000-0000-000000000000}"/>
          </ac:spMkLst>
        </pc:spChg>
        <pc:spChg chg="mod">
          <ac:chgData name="三好　慶太郎" userId="885fdf61-c477-4ebd-a6d8-2867af3f3102" providerId="ADAL" clId="{61F3CF6B-BC69-4343-9209-F0998CBB8C20}" dt="2023-09-26T01:14:58.380" v="17" actId="113"/>
          <ac:spMkLst>
            <pc:docMk/>
            <pc:sldMk cId="3509598072" sldId="266"/>
            <ac:spMk id="38" creationId="{00000000-0000-0000-0000-000000000000}"/>
          </ac:spMkLst>
        </pc:spChg>
        <pc:picChg chg="mod">
          <ac:chgData name="三好　慶太郎" userId="885fdf61-c477-4ebd-a6d8-2867af3f3102" providerId="ADAL" clId="{61F3CF6B-BC69-4343-9209-F0998CBB8C20}" dt="2023-09-26T00:22:23.378" v="11" actId="1076"/>
          <ac:picMkLst>
            <pc:docMk/>
            <pc:sldMk cId="3509598072" sldId="266"/>
            <ac:picMk id="1031" creationId="{00000000-0000-0000-0000-000000000000}"/>
          </ac:picMkLst>
        </pc:picChg>
      </pc:sldChg>
    </pc:docChg>
  </pc:docChgLst>
  <pc:docChgLst>
    <pc:chgData name="前川　正充" userId="ec498de6-dd87-4767-be4a-a3286ad2b65a" providerId="ADAL" clId="{F69C1F26-36BB-4743-ADBC-FFDD87113AD1}"/>
    <pc:docChg chg="custSel delSld modSld">
      <pc:chgData name="前川　正充" userId="ec498de6-dd87-4767-be4a-a3286ad2b65a" providerId="ADAL" clId="{F69C1F26-36BB-4743-ADBC-FFDD87113AD1}" dt="2022-12-24T06:44:16.794" v="54" actId="478"/>
      <pc:docMkLst>
        <pc:docMk/>
      </pc:docMkLst>
      <pc:sldChg chg="del">
        <pc:chgData name="前川　正充" userId="ec498de6-dd87-4767-be4a-a3286ad2b65a" providerId="ADAL" clId="{F69C1F26-36BB-4743-ADBC-FFDD87113AD1}" dt="2022-12-24T06:24:23.586" v="1" actId="47"/>
        <pc:sldMkLst>
          <pc:docMk/>
          <pc:sldMk cId="559186644" sldId="259"/>
        </pc:sldMkLst>
      </pc:sldChg>
      <pc:sldChg chg="del">
        <pc:chgData name="前川　正充" userId="ec498de6-dd87-4767-be4a-a3286ad2b65a" providerId="ADAL" clId="{F69C1F26-36BB-4743-ADBC-FFDD87113AD1}" dt="2022-12-24T06:24:24.485" v="2" actId="47"/>
        <pc:sldMkLst>
          <pc:docMk/>
          <pc:sldMk cId="3045414556" sldId="260"/>
        </pc:sldMkLst>
      </pc:sldChg>
      <pc:sldChg chg="del">
        <pc:chgData name="前川　正充" userId="ec498de6-dd87-4767-be4a-a3286ad2b65a" providerId="ADAL" clId="{F69C1F26-36BB-4743-ADBC-FFDD87113AD1}" dt="2022-12-24T06:24:22.954" v="0" actId="47"/>
        <pc:sldMkLst>
          <pc:docMk/>
          <pc:sldMk cId="2547117403" sldId="261"/>
        </pc:sldMkLst>
      </pc:sldChg>
      <pc:sldChg chg="del">
        <pc:chgData name="前川　正充" userId="ec498de6-dd87-4767-be4a-a3286ad2b65a" providerId="ADAL" clId="{F69C1F26-36BB-4743-ADBC-FFDD87113AD1}" dt="2022-12-24T06:24:25.209" v="3" actId="47"/>
        <pc:sldMkLst>
          <pc:docMk/>
          <pc:sldMk cId="1745094647" sldId="262"/>
        </pc:sldMkLst>
      </pc:sldChg>
      <pc:sldChg chg="del">
        <pc:chgData name="前川　正充" userId="ec498de6-dd87-4767-be4a-a3286ad2b65a" providerId="ADAL" clId="{F69C1F26-36BB-4743-ADBC-FFDD87113AD1}" dt="2022-12-24T06:24:27.394" v="7" actId="47"/>
        <pc:sldMkLst>
          <pc:docMk/>
          <pc:sldMk cId="220952807" sldId="265"/>
        </pc:sldMkLst>
      </pc:sldChg>
      <pc:sldChg chg="addSp delSp modSp mod">
        <pc:chgData name="前川　正充" userId="ec498de6-dd87-4767-be4a-a3286ad2b65a" providerId="ADAL" clId="{F69C1F26-36BB-4743-ADBC-FFDD87113AD1}" dt="2022-12-24T06:44:16.794" v="54" actId="478"/>
        <pc:sldMkLst>
          <pc:docMk/>
          <pc:sldMk cId="3509598072" sldId="266"/>
        </pc:sldMkLst>
        <pc:spChg chg="add 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2" creationId="{99DF83ED-CF62-EB2C-95DE-5CC12BA29E26}"/>
          </ac:spMkLst>
        </pc:spChg>
        <pc:spChg chg="del">
          <ac:chgData name="前川　正充" userId="ec498de6-dd87-4767-be4a-a3286ad2b65a" providerId="ADAL" clId="{F69C1F26-36BB-4743-ADBC-FFDD87113AD1}" dt="2022-12-24T06:43:11.122" v="52" actId="478"/>
          <ac:spMkLst>
            <pc:docMk/>
            <pc:sldMk cId="3509598072" sldId="266"/>
            <ac:spMk id="3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4" creationId="{00000000-0000-0000-0000-000000000000}"/>
          </ac:spMkLst>
        </pc:spChg>
        <pc:spChg chg="add del mod">
          <ac:chgData name="前川　正充" userId="ec498de6-dd87-4767-be4a-a3286ad2b65a" providerId="ADAL" clId="{F69C1F26-36BB-4743-ADBC-FFDD87113AD1}" dt="2022-12-24T06:35:13.601" v="32" actId="478"/>
          <ac:spMkLst>
            <pc:docMk/>
            <pc:sldMk cId="3509598072" sldId="266"/>
            <ac:spMk id="5" creationId="{62C61AF9-F87D-87BC-C8D8-87B237680AE7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12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13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14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15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16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17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18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19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20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23" creationId="{00000000-0000-0000-0000-000000000000}"/>
          </ac:spMkLst>
        </pc:spChg>
        <pc:spChg chg="del mod">
          <ac:chgData name="前川　正充" userId="ec498de6-dd87-4767-be4a-a3286ad2b65a" providerId="ADAL" clId="{F69C1F26-36BB-4743-ADBC-FFDD87113AD1}" dt="2022-12-24T06:44:16.794" v="54" actId="478"/>
          <ac:spMkLst>
            <pc:docMk/>
            <pc:sldMk cId="3509598072" sldId="266"/>
            <ac:spMk id="24" creationId="{00000000-0000-0000-0000-000000000000}"/>
          </ac:spMkLst>
        </pc:spChg>
        <pc:spChg chg="del">
          <ac:chgData name="前川　正充" userId="ec498de6-dd87-4767-be4a-a3286ad2b65a" providerId="ADAL" clId="{F69C1F26-36BB-4743-ADBC-FFDD87113AD1}" dt="2022-12-24T06:24:32.473" v="8" actId="478"/>
          <ac:spMkLst>
            <pc:docMk/>
            <pc:sldMk cId="3509598072" sldId="266"/>
            <ac:spMk id="25" creationId="{00000000-0000-0000-0000-000000000000}"/>
          </ac:spMkLst>
        </pc:spChg>
        <pc:spChg chg="del">
          <ac:chgData name="前川　正充" userId="ec498de6-dd87-4767-be4a-a3286ad2b65a" providerId="ADAL" clId="{F69C1F26-36BB-4743-ADBC-FFDD87113AD1}" dt="2022-12-24T06:24:32.473" v="8" actId="478"/>
          <ac:spMkLst>
            <pc:docMk/>
            <pc:sldMk cId="3509598072" sldId="266"/>
            <ac:spMk id="26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31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32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33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34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35" creationId="{00000000-0000-0000-0000-000000000000}"/>
          </ac:spMkLst>
        </pc:spChg>
        <pc:spChg chg="mod">
          <ac:chgData name="前川　正充" userId="ec498de6-dd87-4767-be4a-a3286ad2b65a" providerId="ADAL" clId="{F69C1F26-36BB-4743-ADBC-FFDD87113AD1}" dt="2022-12-24T06:44:03.308" v="53" actId="2711"/>
          <ac:spMkLst>
            <pc:docMk/>
            <pc:sldMk cId="3509598072" sldId="266"/>
            <ac:spMk id="38" creationId="{00000000-0000-0000-0000-000000000000}"/>
          </ac:spMkLst>
        </pc:spChg>
        <pc:picChg chg="mod">
          <ac:chgData name="前川　正充" userId="ec498de6-dd87-4767-be4a-a3286ad2b65a" providerId="ADAL" clId="{F69C1F26-36BB-4743-ADBC-FFDD87113AD1}" dt="2022-12-24T06:44:03.308" v="53" actId="2711"/>
          <ac:picMkLst>
            <pc:docMk/>
            <pc:sldMk cId="3509598072" sldId="266"/>
            <ac:picMk id="1030" creationId="{00000000-0000-0000-0000-000000000000}"/>
          </ac:picMkLst>
        </pc:picChg>
        <pc:picChg chg="mod">
          <ac:chgData name="前川　正充" userId="ec498de6-dd87-4767-be4a-a3286ad2b65a" providerId="ADAL" clId="{F69C1F26-36BB-4743-ADBC-FFDD87113AD1}" dt="2022-12-24T06:44:03.308" v="53" actId="2711"/>
          <ac:picMkLst>
            <pc:docMk/>
            <pc:sldMk cId="3509598072" sldId="266"/>
            <ac:picMk id="1031" creationId="{00000000-0000-0000-0000-000000000000}"/>
          </ac:picMkLst>
        </pc:picChg>
      </pc:sldChg>
      <pc:sldChg chg="del">
        <pc:chgData name="前川　正充" userId="ec498de6-dd87-4767-be4a-a3286ad2b65a" providerId="ADAL" clId="{F69C1F26-36BB-4743-ADBC-FFDD87113AD1}" dt="2022-12-24T06:35:09.869" v="31" actId="47"/>
        <pc:sldMkLst>
          <pc:docMk/>
          <pc:sldMk cId="3328546841" sldId="267"/>
        </pc:sldMkLst>
      </pc:sldChg>
      <pc:sldChg chg="del">
        <pc:chgData name="前川　正充" userId="ec498de6-dd87-4767-be4a-a3286ad2b65a" providerId="ADAL" clId="{F69C1F26-36BB-4743-ADBC-FFDD87113AD1}" dt="2022-12-24T06:35:09.869" v="31" actId="47"/>
        <pc:sldMkLst>
          <pc:docMk/>
          <pc:sldMk cId="1129210671" sldId="269"/>
        </pc:sldMkLst>
      </pc:sldChg>
      <pc:sldChg chg="del">
        <pc:chgData name="前川　正充" userId="ec498de6-dd87-4767-be4a-a3286ad2b65a" providerId="ADAL" clId="{F69C1F26-36BB-4743-ADBC-FFDD87113AD1}" dt="2022-12-24T06:35:09.869" v="31" actId="47"/>
        <pc:sldMkLst>
          <pc:docMk/>
          <pc:sldMk cId="3038913956" sldId="271"/>
        </pc:sldMkLst>
      </pc:sldChg>
      <pc:sldChg chg="del">
        <pc:chgData name="前川　正充" userId="ec498de6-dd87-4767-be4a-a3286ad2b65a" providerId="ADAL" clId="{F69C1F26-36BB-4743-ADBC-FFDD87113AD1}" dt="2022-12-24T06:35:09.869" v="31" actId="47"/>
        <pc:sldMkLst>
          <pc:docMk/>
          <pc:sldMk cId="0" sldId="290"/>
        </pc:sldMkLst>
      </pc:sldChg>
      <pc:sldChg chg="del">
        <pc:chgData name="前川　正充" userId="ec498de6-dd87-4767-be4a-a3286ad2b65a" providerId="ADAL" clId="{F69C1F26-36BB-4743-ADBC-FFDD87113AD1}" dt="2022-12-24T06:35:09.869" v="31" actId="47"/>
        <pc:sldMkLst>
          <pc:docMk/>
          <pc:sldMk cId="675595375" sldId="363"/>
        </pc:sldMkLst>
      </pc:sldChg>
      <pc:sldChg chg="del">
        <pc:chgData name="前川　正充" userId="ec498de6-dd87-4767-be4a-a3286ad2b65a" providerId="ADAL" clId="{F69C1F26-36BB-4743-ADBC-FFDD87113AD1}" dt="2022-12-24T06:35:09.869" v="31" actId="47"/>
        <pc:sldMkLst>
          <pc:docMk/>
          <pc:sldMk cId="3563485879" sldId="364"/>
        </pc:sldMkLst>
      </pc:sldChg>
      <pc:sldChg chg="del">
        <pc:chgData name="前川　正充" userId="ec498de6-dd87-4767-be4a-a3286ad2b65a" providerId="ADAL" clId="{F69C1F26-36BB-4743-ADBC-FFDD87113AD1}" dt="2022-12-24T06:35:09.869" v="31" actId="47"/>
        <pc:sldMkLst>
          <pc:docMk/>
          <pc:sldMk cId="2406307192" sldId="373"/>
        </pc:sldMkLst>
      </pc:sldChg>
      <pc:sldChg chg="del">
        <pc:chgData name="前川　正充" userId="ec498de6-dd87-4767-be4a-a3286ad2b65a" providerId="ADAL" clId="{F69C1F26-36BB-4743-ADBC-FFDD87113AD1}" dt="2022-12-24T06:35:09.869" v="31" actId="47"/>
        <pc:sldMkLst>
          <pc:docMk/>
          <pc:sldMk cId="1327557088" sldId="374"/>
        </pc:sldMkLst>
      </pc:sldChg>
      <pc:sldChg chg="del">
        <pc:chgData name="前川　正充" userId="ec498de6-dd87-4767-be4a-a3286ad2b65a" providerId="ADAL" clId="{F69C1F26-36BB-4743-ADBC-FFDD87113AD1}" dt="2022-12-24T06:24:26.824" v="6" actId="47"/>
        <pc:sldMkLst>
          <pc:docMk/>
          <pc:sldMk cId="1823158687" sldId="375"/>
        </pc:sldMkLst>
      </pc:sldChg>
      <pc:sldChg chg="del">
        <pc:chgData name="前川　正充" userId="ec498de6-dd87-4767-be4a-a3286ad2b65a" providerId="ADAL" clId="{F69C1F26-36BB-4743-ADBC-FFDD87113AD1}" dt="2022-12-24T06:24:26.285" v="5" actId="47"/>
        <pc:sldMkLst>
          <pc:docMk/>
          <pc:sldMk cId="1265931467" sldId="376"/>
        </pc:sldMkLst>
      </pc:sldChg>
      <pc:sldChg chg="del">
        <pc:chgData name="前川　正充" userId="ec498de6-dd87-4767-be4a-a3286ad2b65a" providerId="ADAL" clId="{F69C1F26-36BB-4743-ADBC-FFDD87113AD1}" dt="2022-12-24T06:24:25.811" v="4" actId="47"/>
        <pc:sldMkLst>
          <pc:docMk/>
          <pc:sldMk cId="2838096007" sldId="377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5E91C8-5A67-42DC-B5B7-064AB29CDABE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3164338-F72B-416B-B88F-28EE2CDE666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6880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>
          <a:xfrm>
            <a:off x="711200" y="744538"/>
            <a:ext cx="5375275" cy="3722687"/>
          </a:xfrm>
        </p:spPr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defTabSz="921075"/>
            <a:r>
              <a:rPr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Fig. S1	Immunoblotting of NPC1 in cells.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WT, hep G2 cells; KO1, site A and C mutant NPC1 model cells; KO1, site B and D mutant NPC1 model cells.</a:t>
            </a: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99E3809-4B99-4D89-808F-9DFDF6B28A92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431091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371857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39618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80058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8858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4723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43551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0678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520806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63278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51214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17741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BEDD97-F814-415C-89D2-D41F7B081706}" type="datetimeFigureOut">
              <a:rPr kumimoji="1" lang="ja-JP" altLang="en-US" smtClean="0"/>
              <a:t>2023/9/2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29F82F-5A4D-41A8-82AF-A518E1526B8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6758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60578" y="5801927"/>
            <a:ext cx="946524" cy="426756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74257" y="1775872"/>
            <a:ext cx="919167" cy="398031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" name="テキスト ボックス 3"/>
          <p:cNvSpPr txBox="1"/>
          <p:nvPr/>
        </p:nvSpPr>
        <p:spPr>
          <a:xfrm>
            <a:off x="5398412" y="2072481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- 250K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398412" y="2415758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- 150K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5398412" y="2755188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- 100K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5398412" y="3014302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-   75K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5398412" y="3704104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-   50K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5398412" y="4098246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-   37K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5398412" y="4574055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-   25K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5398412" y="4789399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-   20K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5398412" y="499380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-   15K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5398412" y="5150713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-   10K</a:t>
            </a:r>
            <a:endParaRPr kumimoji="1" lang="ja-JP" altLang="en-US" sz="14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3691669" y="2276872"/>
            <a:ext cx="9717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NPC1 -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1" name="テキスト ボックス 30"/>
          <p:cNvSpPr txBox="1"/>
          <p:nvPr/>
        </p:nvSpPr>
        <p:spPr>
          <a:xfrm>
            <a:off x="3501007" y="5817026"/>
            <a:ext cx="11721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GAPDH -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2" name="テキスト ボックス 31"/>
          <p:cNvSpPr txBox="1"/>
          <p:nvPr/>
        </p:nvSpPr>
        <p:spPr>
          <a:xfrm>
            <a:off x="4613833" y="141277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</a:t>
            </a:r>
            <a:endParaRPr kumimoji="1" lang="ja-JP" altLang="en-US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/>
          <p:cNvSpPr txBox="1"/>
          <p:nvPr/>
        </p:nvSpPr>
        <p:spPr>
          <a:xfrm>
            <a:off x="4891591" y="141277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2</a:t>
            </a:r>
            <a:endParaRPr kumimoji="1" lang="ja-JP" altLang="en-US" dirty="0">
              <a:solidFill>
                <a:srgbClr val="FF000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4" name="テキスト ボックス 33"/>
          <p:cNvSpPr txBox="1"/>
          <p:nvPr/>
        </p:nvSpPr>
        <p:spPr>
          <a:xfrm>
            <a:off x="5169349" y="141277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solidFill>
                  <a:srgbClr val="FF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</a:t>
            </a:r>
            <a:endParaRPr kumimoji="1" lang="ja-JP" altLang="en-US" dirty="0">
              <a:solidFill>
                <a:srgbClr val="FF0000"/>
              </a:solidFill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35" name="テキスト ボックス 34"/>
          <p:cNvSpPr txBox="1"/>
          <p:nvPr/>
        </p:nvSpPr>
        <p:spPr>
          <a:xfrm>
            <a:off x="6446415" y="1565176"/>
            <a:ext cx="1313180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  WT cell</a:t>
            </a:r>
          </a:p>
          <a:p>
            <a:r>
              <a:rPr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2  </a:t>
            </a:r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KO1 cell</a:t>
            </a:r>
            <a:endParaRPr lang="en-US" altLang="ja-JP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  <a:p>
            <a:r>
              <a:rPr lang="en-US" altLang="ja-JP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3  </a:t>
            </a:r>
            <a:r>
              <a:rPr lang="en-US" altLang="ja-JP" dirty="0">
                <a:solidFill>
                  <a:srgbClr val="FF0000"/>
                </a:solidFill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KO2 cell</a:t>
            </a:r>
          </a:p>
        </p:txBody>
      </p:sp>
      <p:sp>
        <p:nvSpPr>
          <p:cNvPr id="38" name="テキスト ボックス 37"/>
          <p:cNvSpPr txBox="1"/>
          <p:nvPr/>
        </p:nvSpPr>
        <p:spPr>
          <a:xfrm>
            <a:off x="56456" y="1801495"/>
            <a:ext cx="3358996" cy="152400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kumimoji="1" lang="en-US" altLang="ja-JP" sz="16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10 </a:t>
            </a:r>
            <a:r>
              <a:rPr kumimoji="1" lang="en-US" altLang="ja-JP" sz="1600" dirty="0" err="1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μg</a:t>
            </a:r>
            <a:r>
              <a:rPr kumimoji="1" lang="en-US" altLang="ja-JP" sz="16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 proteins/lane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altLang="ja-JP" sz="16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Anti-NPC1(</a:t>
            </a:r>
            <a:r>
              <a:rPr lang="en-US" altLang="ja-JP" sz="1600" dirty="0" err="1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Abcam</a:t>
            </a:r>
            <a:r>
              <a:rPr lang="en-US" altLang="ja-JP" sz="16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 ab55706)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r>
              <a:rPr lang="en-US" altLang="ja-JP" sz="1600" dirty="0">
                <a:latin typeface="Arial" panose="020B0604020202020204" pitchFamily="34" charset="0"/>
                <a:ea typeface="Meiryo UI" panose="020B0604030504040204" pitchFamily="50" charset="-128"/>
                <a:cs typeface="Arial" panose="020B0604020202020204" pitchFamily="34" charset="0"/>
              </a:rPr>
              <a:t>Anti-GAPDH(Wako 5A12 clone)</a:t>
            </a:r>
          </a:p>
          <a:p>
            <a:pPr marL="285750" indent="-285750">
              <a:lnSpc>
                <a:spcPct val="150000"/>
              </a:lnSpc>
              <a:buFont typeface="Wingdings" panose="05000000000000000000" pitchFamily="2" charset="2"/>
              <a:buChar char="Ø"/>
            </a:pPr>
            <a:endParaRPr lang="en-US" altLang="ja-JP" sz="1600" dirty="0">
              <a:latin typeface="Arial" panose="020B0604020202020204" pitchFamily="34" charset="0"/>
              <a:ea typeface="Meiryo UI" panose="020B0604030504040204" pitchFamily="50" charset="-128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9DF83ED-CF62-EB2C-95DE-5CC12BA29E26}"/>
              </a:ext>
            </a:extLst>
          </p:cNvPr>
          <p:cNvSpPr txBox="1"/>
          <p:nvPr/>
        </p:nvSpPr>
        <p:spPr>
          <a:xfrm>
            <a:off x="7092409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Miyoshi K., et al. Fig. S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95980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2</TotalTime>
  <Words>100</Words>
  <Application>Microsoft Office PowerPoint</Application>
  <PresentationFormat>A4 210 x 297 mm</PresentationFormat>
  <Paragraphs>25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Wingdings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深澤征義</dc:creator>
  <cp:lastModifiedBy>三好　慶太郎</cp:lastModifiedBy>
  <cp:revision>3</cp:revision>
  <dcterms:created xsi:type="dcterms:W3CDTF">2022-07-13T23:31:33Z</dcterms:created>
  <dcterms:modified xsi:type="dcterms:W3CDTF">2023-09-26T01:15:00Z</dcterms:modified>
</cp:coreProperties>
</file>